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10" Type="http://schemas.openxmlformats.org/officeDocument/2006/relationships/customXml" Target="../customXml/item3.xml"/><Relationship Id="rId4" Type="http://schemas.openxmlformats.org/officeDocument/2006/relationships/viewProps" Target="viewProps.xml"/><Relationship Id="rId9" Type="http://schemas.openxmlformats.org/officeDocument/2006/relationships/customXml" Target="../customXml/item2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gwick Phil GBJH" userId="1b19963b-d144-407c-967e-3468dfeb8a6a" providerId="ADAL" clId="{7CB2BFB8-F419-4C32-8033-2CD3B44D31AA}"/>
    <pc:docChg chg="delSld">
      <pc:chgData name="Madgwick Phil GBJH" userId="1b19963b-d144-407c-967e-3468dfeb8a6a" providerId="ADAL" clId="{7CB2BFB8-F419-4C32-8033-2CD3B44D31AA}" dt="2023-06-09T15:34:02.470" v="0" actId="47"/>
      <pc:docMkLst>
        <pc:docMk/>
      </pc:docMkLst>
      <pc:sldChg chg="del">
        <pc:chgData name="Madgwick Phil GBJH" userId="1b19963b-d144-407c-967e-3468dfeb8a6a" providerId="ADAL" clId="{7CB2BFB8-F419-4C32-8033-2CD3B44D31AA}" dt="2023-06-09T15:34:02.470" v="0" actId="47"/>
        <pc:sldMkLst>
          <pc:docMk/>
          <pc:sldMk cId="1132146932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7E70A6-C28D-1F59-487C-9B276D86F4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EAAF57-D57A-7A23-992D-F798650741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0D907-4623-82F9-80DE-A812752DF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A70624-3AC6-2E71-DA44-EE2A01CC4D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3598C9-712E-044F-9DC9-560D76F82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1176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5A23B-436E-B504-19F2-8C33E6F35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ADF3AE-865B-BF70-B348-CF4623CD29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9481C-4C2A-A516-86D0-C0AEC669B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2196D4-D548-BA48-6173-E1F2ACB0D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95E7EB-C3B8-521D-0A84-358239A0B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521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AD76B2-778A-2500-76DD-B960B6D9BB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E1260D-0E99-E6A4-1422-3C3EB18A2D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3D565-B6B5-192B-6017-A52746281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70456A-D45C-CF75-6463-74F84BF59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211DD-A6A1-CAD8-2982-0F1AC7C9C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6023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B32CBB-A31C-7FB5-A8B8-1DBD30352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8D6B61-9804-17D9-A176-719360B835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7BC8E-0AC3-08B7-796C-082A387B9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F761A2-7F8A-5928-19D4-CA33E0E37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3CC8BB-1BDE-276B-6F7D-A0F137BB8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787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BA5845-A895-5191-B0DD-37356F6C72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C26903-16AA-4442-778B-0DB0A6D0FF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481D39-39CE-7B10-6096-F7E5B5716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3408C1-210E-8883-47C3-445AE8B06E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8F001-D7C6-8AC2-BC88-A7AA67A75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3862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B89DD-0908-C8FD-0458-1D9BFE317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B70C62-27F8-C5B8-ECA7-551D0CD3AA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E78A74-09C7-F3BE-9F06-45D5F66AD6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CCD751-CD1B-C4A8-DE2F-F9CC10E04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20DE88-B948-4E31-A784-A63DC429D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579273-F5B8-BAE6-EF64-4FACB0731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4672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E4F6A-9F49-7802-24FA-7026A099E3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77A8E6-BFE2-5BA1-A412-5743B00EC8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55A530-5103-1271-31A6-E96335200A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F82B42-60B2-4741-FC4A-631FE7296A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6A99FE-87E7-5825-9286-E3459C24E3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C22251-034C-D1AD-48BE-256288CEC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8F716F-F8F9-7303-6432-89CBE3F68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244614-8F31-228F-E2BA-1F6FF84A7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210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E8C14B-0DDA-2627-57CA-92286828C5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BDE783-FB44-B89A-EB41-3C1B5A8B0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177AB4-9611-799D-327D-D829A5D45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530ABC-A7BC-783E-E435-D0D8DBC91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0207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92AEE0-0150-17C8-B982-29E8ED8D63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BB8584-ADAA-B1A0-31EB-B9D2074AE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28B1BF-657D-33E2-C3C3-D43C08B45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4241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763FE5-3E5C-1776-2363-330E98688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D651C8-A582-4355-D7D8-7DDA11E345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DA95EC-B211-8276-ED60-DA364DAA84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11EFD6-9C95-5C30-86FE-447AF1FF8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3CA1BA-0399-4E67-C410-27948E6FA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E696FE-9167-2E6B-0962-FA618458D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5662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89627-A9EE-7787-13D1-016F0D1E48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BD8793F-F3F1-9068-D6E0-739CF24AE5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74A408-87C7-4B09-6A28-55EA984FF9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97175D-F33A-13B6-880E-38EF58685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EEA362-8E49-EC7B-8A2B-E320AE963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3BAFA9-89AF-3696-4016-BC229A84A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4151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BAE335-6B90-B32F-425C-FF0015BB19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9E4FF6-95B9-7020-228F-BE87F54E8F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B15E2-22D5-8623-9C6F-0BABBA6942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A40EEF-FF5B-4655-9F62-37B83DD8341C}" type="datetimeFigureOut">
              <a:rPr lang="en-GB" smtClean="0"/>
              <a:t>09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675604-0749-F94B-8630-71B1BFD9AB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5F7E5E-4509-D578-D99C-B004DA5C6E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A472C-DAD9-49A8-A749-F94006CBED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673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>
            <a:extLst>
              <a:ext uri="{FF2B5EF4-FFF2-40B4-BE49-F238E27FC236}">
                <a16:creationId xmlns:a16="http://schemas.microsoft.com/office/drawing/2014/main" id="{C353CB55-D4BA-2FA8-1B57-616EE194D2FF}"/>
              </a:ext>
            </a:extLst>
          </p:cNvPr>
          <p:cNvSpPr/>
          <p:nvPr/>
        </p:nvSpPr>
        <p:spPr>
          <a:xfrm>
            <a:off x="2731867" y="721451"/>
            <a:ext cx="1620000" cy="8221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/>
              <a:t>Treatment of a fibre with </a:t>
            </a:r>
            <a:r>
              <a:rPr lang="en-GB" sz="1100" b="1" dirty="0">
                <a:solidFill>
                  <a:srgbClr val="C00000"/>
                </a:solidFill>
              </a:rPr>
              <a:t>variable loading concentrations </a:t>
            </a:r>
            <a:r>
              <a:rPr lang="en-GB" sz="1100" dirty="0"/>
              <a:t>of </a:t>
            </a:r>
            <a:r>
              <a:rPr lang="en-GB" sz="1100" b="1" dirty="0">
                <a:solidFill>
                  <a:schemeClr val="tx1"/>
                </a:solidFill>
              </a:rPr>
              <a:t>a chosen insecticide 1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75D23F6-0C4F-77FF-C88D-19D5A19D6426}"/>
              </a:ext>
            </a:extLst>
          </p:cNvPr>
          <p:cNvSpPr/>
          <p:nvPr/>
        </p:nvSpPr>
        <p:spPr>
          <a:xfrm>
            <a:off x="7840134" y="721450"/>
            <a:ext cx="1620000" cy="8221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/>
              <a:t>Treatment of a fibre with </a:t>
            </a:r>
            <a:r>
              <a:rPr lang="en-GB" sz="1100" b="1" dirty="0">
                <a:solidFill>
                  <a:srgbClr val="0070C0"/>
                </a:solidFill>
              </a:rPr>
              <a:t>variable loading concentrations </a:t>
            </a:r>
            <a:r>
              <a:rPr lang="en-GB" sz="1100" dirty="0"/>
              <a:t>of</a:t>
            </a:r>
            <a:r>
              <a:rPr lang="en-GB" sz="1100" b="1" dirty="0"/>
              <a:t> </a:t>
            </a:r>
            <a:r>
              <a:rPr lang="en-GB" sz="1100" b="1" dirty="0">
                <a:solidFill>
                  <a:schemeClr val="tx1"/>
                </a:solidFill>
              </a:rPr>
              <a:t>a chosen insecticide 2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AE10EFD-4CCE-2F41-EAA6-DFC55D63C0D4}"/>
              </a:ext>
            </a:extLst>
          </p:cNvPr>
          <p:cNvSpPr/>
          <p:nvPr/>
        </p:nvSpPr>
        <p:spPr>
          <a:xfrm>
            <a:off x="3256831" y="2123487"/>
            <a:ext cx="1620000" cy="8221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/>
              <a:t>Physical durability of LLIN fabric as a mosquito barrier over a</a:t>
            </a:r>
            <a:r>
              <a:rPr lang="en-GB" sz="1100" b="1" dirty="0"/>
              <a:t> </a:t>
            </a:r>
            <a:r>
              <a:rPr lang="en-GB" sz="1100" b="1" dirty="0">
                <a:solidFill>
                  <a:srgbClr val="7030A0"/>
                </a:solidFill>
              </a:rPr>
              <a:t>variable deployment lifespan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B5878657-0E2B-B6E8-CA70-3152DDB6835E}"/>
              </a:ext>
            </a:extLst>
          </p:cNvPr>
          <p:cNvSpPr/>
          <p:nvPr/>
        </p:nvSpPr>
        <p:spPr>
          <a:xfrm>
            <a:off x="7309597" y="2122872"/>
            <a:ext cx="1620000" cy="8221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/>
              <a:t>Chemical durability of LLIN insecticides as a control over </a:t>
            </a:r>
            <a:r>
              <a:rPr lang="en-GB" sz="1100" b="1" dirty="0">
                <a:solidFill>
                  <a:srgbClr val="7030A0"/>
                </a:solidFill>
              </a:rPr>
              <a:t>variable deployment lifespans</a:t>
            </a:r>
          </a:p>
        </p:txBody>
      </p:sp>
      <p:pic>
        <p:nvPicPr>
          <p:cNvPr id="32" name="Graphic 31" descr="Mosquito with solid fill">
            <a:extLst>
              <a:ext uri="{FF2B5EF4-FFF2-40B4-BE49-F238E27FC236}">
                <a16:creationId xmlns:a16="http://schemas.microsoft.com/office/drawing/2014/main" id="{57CC4AB7-BFCA-672E-D4AA-CCC2834A01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rot="10800000">
            <a:off x="5679741" y="4924339"/>
            <a:ext cx="822120" cy="822120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3BC89FDD-DADE-9C44-A326-3CFF2F7A86DB}"/>
              </a:ext>
            </a:extLst>
          </p:cNvPr>
          <p:cNvSpPr/>
          <p:nvPr/>
        </p:nvSpPr>
        <p:spPr>
          <a:xfrm>
            <a:off x="2731867" y="5881012"/>
            <a:ext cx="6728267" cy="473979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/>
              <a:t>Optimization of loading concentrations and deployment lifespans to maximize vector control over the simulation, with the genetic evolution of resistance and density-dependent population dynamics</a:t>
            </a:r>
          </a:p>
        </p:txBody>
      </p:sp>
      <p:pic>
        <p:nvPicPr>
          <p:cNvPr id="36" name="Graphic 35" descr="Dollar with solid fill">
            <a:extLst>
              <a:ext uri="{FF2B5EF4-FFF2-40B4-BE49-F238E27FC236}">
                <a16:creationId xmlns:a16="http://schemas.microsoft.com/office/drawing/2014/main" id="{7DCFDEF4-6972-CA07-707A-F868595BD1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538535" y="3524289"/>
            <a:ext cx="822121" cy="822121"/>
          </a:xfrm>
          <a:prstGeom prst="rect">
            <a:avLst/>
          </a:prstGeom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6643160B-B93A-3B18-BC96-768440AF35D4}"/>
              </a:ext>
            </a:extLst>
          </p:cNvPr>
          <p:cNvSpPr/>
          <p:nvPr/>
        </p:nvSpPr>
        <p:spPr>
          <a:xfrm>
            <a:off x="7840134" y="3524291"/>
            <a:ext cx="1620000" cy="8221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A</a:t>
            </a:r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b="1" dirty="0">
                <a:solidFill>
                  <a:schemeClr val="tx1"/>
                </a:solidFill>
              </a:rPr>
              <a:t>chosen public health budget</a:t>
            </a:r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dirty="0"/>
              <a:t>is spent on a level of coverage for the designed LLIN</a:t>
            </a:r>
          </a:p>
        </p:txBody>
      </p:sp>
      <p:sp>
        <p:nvSpPr>
          <p:cNvPr id="38" name="Freeform: Shape 37">
            <a:extLst>
              <a:ext uri="{FF2B5EF4-FFF2-40B4-BE49-F238E27FC236}">
                <a16:creationId xmlns:a16="http://schemas.microsoft.com/office/drawing/2014/main" id="{E481F71F-AA58-FE73-67AB-09708F9A4E78}"/>
              </a:ext>
            </a:extLst>
          </p:cNvPr>
          <p:cNvSpPr/>
          <p:nvPr/>
        </p:nvSpPr>
        <p:spPr>
          <a:xfrm>
            <a:off x="5579126" y="2122871"/>
            <a:ext cx="569291" cy="822121"/>
          </a:xfrm>
          <a:custGeom>
            <a:avLst/>
            <a:gdLst>
              <a:gd name="connsiteX0" fmla="*/ 520117 w 520117"/>
              <a:gd name="connsiteY0" fmla="*/ 0 h 1308682"/>
              <a:gd name="connsiteX1" fmla="*/ 192947 w 520117"/>
              <a:gd name="connsiteY1" fmla="*/ 419449 h 1308682"/>
              <a:gd name="connsiteX2" fmla="*/ 0 w 520117"/>
              <a:gd name="connsiteY2" fmla="*/ 1308682 h 13086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0117" h="1308682">
                <a:moveTo>
                  <a:pt x="520117" y="0"/>
                </a:moveTo>
                <a:cubicBezTo>
                  <a:pt x="399875" y="100667"/>
                  <a:pt x="279633" y="201335"/>
                  <a:pt x="192947" y="419449"/>
                </a:cubicBezTo>
                <a:cubicBezTo>
                  <a:pt x="106261" y="637563"/>
                  <a:pt x="53130" y="973122"/>
                  <a:pt x="0" y="1308682"/>
                </a:cubicBezTo>
              </a:path>
            </a:pathLst>
          </a:custGeom>
          <a:ln w="12700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804034D0-CE56-F66F-4E44-5E33157D02FB}"/>
              </a:ext>
            </a:extLst>
          </p:cNvPr>
          <p:cNvSpPr/>
          <p:nvPr/>
        </p:nvSpPr>
        <p:spPr>
          <a:xfrm>
            <a:off x="5718388" y="2122871"/>
            <a:ext cx="569291" cy="822121"/>
          </a:xfrm>
          <a:custGeom>
            <a:avLst/>
            <a:gdLst>
              <a:gd name="connsiteX0" fmla="*/ 520117 w 520117"/>
              <a:gd name="connsiteY0" fmla="*/ 0 h 1308682"/>
              <a:gd name="connsiteX1" fmla="*/ 192947 w 520117"/>
              <a:gd name="connsiteY1" fmla="*/ 419449 h 1308682"/>
              <a:gd name="connsiteX2" fmla="*/ 0 w 520117"/>
              <a:gd name="connsiteY2" fmla="*/ 1308682 h 13086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0117" h="1308682">
                <a:moveTo>
                  <a:pt x="520117" y="0"/>
                </a:moveTo>
                <a:cubicBezTo>
                  <a:pt x="399875" y="100667"/>
                  <a:pt x="279633" y="201335"/>
                  <a:pt x="192947" y="419449"/>
                </a:cubicBezTo>
                <a:cubicBezTo>
                  <a:pt x="106261" y="637563"/>
                  <a:pt x="53130" y="973122"/>
                  <a:pt x="0" y="1308682"/>
                </a:cubicBezTo>
              </a:path>
            </a:pathLst>
          </a:custGeom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Freeform: Shape 39">
            <a:extLst>
              <a:ext uri="{FF2B5EF4-FFF2-40B4-BE49-F238E27FC236}">
                <a16:creationId xmlns:a16="http://schemas.microsoft.com/office/drawing/2014/main" id="{74EA8C3D-5037-71D0-EA6D-78A58E9F264A}"/>
              </a:ext>
            </a:extLst>
          </p:cNvPr>
          <p:cNvSpPr/>
          <p:nvPr/>
        </p:nvSpPr>
        <p:spPr>
          <a:xfrm>
            <a:off x="5857650" y="2122871"/>
            <a:ext cx="569291" cy="822121"/>
          </a:xfrm>
          <a:custGeom>
            <a:avLst/>
            <a:gdLst>
              <a:gd name="connsiteX0" fmla="*/ 520117 w 520117"/>
              <a:gd name="connsiteY0" fmla="*/ 0 h 1308682"/>
              <a:gd name="connsiteX1" fmla="*/ 192947 w 520117"/>
              <a:gd name="connsiteY1" fmla="*/ 419449 h 1308682"/>
              <a:gd name="connsiteX2" fmla="*/ 0 w 520117"/>
              <a:gd name="connsiteY2" fmla="*/ 1308682 h 13086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0117" h="1308682">
                <a:moveTo>
                  <a:pt x="520117" y="0"/>
                </a:moveTo>
                <a:cubicBezTo>
                  <a:pt x="399875" y="100667"/>
                  <a:pt x="279633" y="201335"/>
                  <a:pt x="192947" y="419449"/>
                </a:cubicBezTo>
                <a:cubicBezTo>
                  <a:pt x="106261" y="637563"/>
                  <a:pt x="53130" y="973122"/>
                  <a:pt x="0" y="1308682"/>
                </a:cubicBezTo>
              </a:path>
            </a:pathLst>
          </a:custGeom>
          <a:ln w="12700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Freeform: Shape 40">
            <a:extLst>
              <a:ext uri="{FF2B5EF4-FFF2-40B4-BE49-F238E27FC236}">
                <a16:creationId xmlns:a16="http://schemas.microsoft.com/office/drawing/2014/main" id="{5C8D3CCA-F19A-6E8A-50C5-E736FFD0EDC4}"/>
              </a:ext>
            </a:extLst>
          </p:cNvPr>
          <p:cNvSpPr/>
          <p:nvPr/>
        </p:nvSpPr>
        <p:spPr>
          <a:xfrm>
            <a:off x="6004495" y="2122871"/>
            <a:ext cx="569291" cy="822121"/>
          </a:xfrm>
          <a:custGeom>
            <a:avLst/>
            <a:gdLst>
              <a:gd name="connsiteX0" fmla="*/ 520117 w 520117"/>
              <a:gd name="connsiteY0" fmla="*/ 0 h 1308682"/>
              <a:gd name="connsiteX1" fmla="*/ 192947 w 520117"/>
              <a:gd name="connsiteY1" fmla="*/ 419449 h 1308682"/>
              <a:gd name="connsiteX2" fmla="*/ 0 w 520117"/>
              <a:gd name="connsiteY2" fmla="*/ 1308682 h 13086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0117" h="1308682">
                <a:moveTo>
                  <a:pt x="520117" y="0"/>
                </a:moveTo>
                <a:cubicBezTo>
                  <a:pt x="399875" y="100667"/>
                  <a:pt x="279633" y="201335"/>
                  <a:pt x="192947" y="419449"/>
                </a:cubicBezTo>
                <a:cubicBezTo>
                  <a:pt x="106261" y="637563"/>
                  <a:pt x="53130" y="973122"/>
                  <a:pt x="0" y="1308682"/>
                </a:cubicBezTo>
              </a:path>
            </a:pathLst>
          </a:custGeom>
          <a:ln w="12700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Freeform: Shape 41">
            <a:extLst>
              <a:ext uri="{FF2B5EF4-FFF2-40B4-BE49-F238E27FC236}">
                <a16:creationId xmlns:a16="http://schemas.microsoft.com/office/drawing/2014/main" id="{4D7683B4-2080-838D-283C-5092262195CA}"/>
              </a:ext>
            </a:extLst>
          </p:cNvPr>
          <p:cNvSpPr/>
          <p:nvPr/>
        </p:nvSpPr>
        <p:spPr>
          <a:xfrm>
            <a:off x="6142295" y="2122871"/>
            <a:ext cx="569291" cy="822121"/>
          </a:xfrm>
          <a:custGeom>
            <a:avLst/>
            <a:gdLst>
              <a:gd name="connsiteX0" fmla="*/ 520117 w 520117"/>
              <a:gd name="connsiteY0" fmla="*/ 0 h 1308682"/>
              <a:gd name="connsiteX1" fmla="*/ 192947 w 520117"/>
              <a:gd name="connsiteY1" fmla="*/ 419449 h 1308682"/>
              <a:gd name="connsiteX2" fmla="*/ 0 w 520117"/>
              <a:gd name="connsiteY2" fmla="*/ 1308682 h 13086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20117" h="1308682">
                <a:moveTo>
                  <a:pt x="520117" y="0"/>
                </a:moveTo>
                <a:cubicBezTo>
                  <a:pt x="399875" y="100667"/>
                  <a:pt x="279633" y="201335"/>
                  <a:pt x="192947" y="419449"/>
                </a:cubicBezTo>
                <a:cubicBezTo>
                  <a:pt x="106261" y="637563"/>
                  <a:pt x="53130" y="973122"/>
                  <a:pt x="0" y="1308682"/>
                </a:cubicBezTo>
              </a:path>
            </a:pathLst>
          </a:custGeom>
          <a:ln w="12700">
            <a:solidFill>
              <a:srgbClr val="C0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3" name="Connector: Curved 42">
            <a:extLst>
              <a:ext uri="{FF2B5EF4-FFF2-40B4-BE49-F238E27FC236}">
                <a16:creationId xmlns:a16="http://schemas.microsoft.com/office/drawing/2014/main" id="{EEBCFF2B-33EA-AE3C-C0DB-62315CA6EC76}"/>
              </a:ext>
            </a:extLst>
          </p:cNvPr>
          <p:cNvCxnSpPr>
            <a:cxnSpLocks/>
          </p:cNvCxnSpPr>
          <p:nvPr/>
        </p:nvCxnSpPr>
        <p:spPr>
          <a:xfrm>
            <a:off x="5718388" y="2238811"/>
            <a:ext cx="855398" cy="105400"/>
          </a:xfrm>
          <a:prstGeom prst="curvedConnector3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or: Curved 43">
            <a:extLst>
              <a:ext uri="{FF2B5EF4-FFF2-40B4-BE49-F238E27FC236}">
                <a16:creationId xmlns:a16="http://schemas.microsoft.com/office/drawing/2014/main" id="{7B81F19E-B25E-48C5-FBA1-DD9664F02FE7}"/>
              </a:ext>
            </a:extLst>
          </p:cNvPr>
          <p:cNvCxnSpPr>
            <a:cxnSpLocks/>
          </p:cNvCxnSpPr>
          <p:nvPr/>
        </p:nvCxnSpPr>
        <p:spPr>
          <a:xfrm>
            <a:off x="5623400" y="2407451"/>
            <a:ext cx="855398" cy="105400"/>
          </a:xfrm>
          <a:prstGeom prst="curvedConnector3">
            <a:avLst/>
          </a:prstGeom>
          <a:ln w="127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or: Curved 44">
            <a:extLst>
              <a:ext uri="{FF2B5EF4-FFF2-40B4-BE49-F238E27FC236}">
                <a16:creationId xmlns:a16="http://schemas.microsoft.com/office/drawing/2014/main" id="{D53359E7-22D7-0ADF-DC57-719A3171C19C}"/>
              </a:ext>
            </a:extLst>
          </p:cNvPr>
          <p:cNvCxnSpPr>
            <a:cxnSpLocks/>
          </p:cNvCxnSpPr>
          <p:nvPr/>
        </p:nvCxnSpPr>
        <p:spPr>
          <a:xfrm>
            <a:off x="5550745" y="2570821"/>
            <a:ext cx="855398" cy="105400"/>
          </a:xfrm>
          <a:prstGeom prst="curvedConnector3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or: Curved 45">
            <a:extLst>
              <a:ext uri="{FF2B5EF4-FFF2-40B4-BE49-F238E27FC236}">
                <a16:creationId xmlns:a16="http://schemas.microsoft.com/office/drawing/2014/main" id="{558F842F-FE01-F664-037D-E9EF02F50EF6}"/>
              </a:ext>
            </a:extLst>
          </p:cNvPr>
          <p:cNvCxnSpPr>
            <a:cxnSpLocks/>
          </p:cNvCxnSpPr>
          <p:nvPr/>
        </p:nvCxnSpPr>
        <p:spPr>
          <a:xfrm>
            <a:off x="5470016" y="2744730"/>
            <a:ext cx="855398" cy="105400"/>
          </a:xfrm>
          <a:prstGeom prst="curvedConnector3">
            <a:avLst/>
          </a:prstGeom>
          <a:ln w="127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id="{39B1EA25-C951-FD58-0476-3D16CB3E8149}"/>
              </a:ext>
            </a:extLst>
          </p:cNvPr>
          <p:cNvSpPr/>
          <p:nvPr/>
        </p:nvSpPr>
        <p:spPr>
          <a:xfrm>
            <a:off x="2731867" y="3524288"/>
            <a:ext cx="1620000" cy="82212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dirty="0">
                <a:solidFill>
                  <a:schemeClr val="tx1"/>
                </a:solidFill>
              </a:rPr>
              <a:t>A</a:t>
            </a:r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b="1" dirty="0">
                <a:solidFill>
                  <a:schemeClr val="tx1"/>
                </a:solidFill>
              </a:rPr>
              <a:t>chosen resistance-management strategy</a:t>
            </a:r>
            <a:r>
              <a:rPr lang="en-GB" sz="1100" dirty="0">
                <a:solidFill>
                  <a:schemeClr val="tx1"/>
                </a:solidFill>
              </a:rPr>
              <a:t> </a:t>
            </a:r>
            <a:r>
              <a:rPr lang="en-GB" sz="1100" dirty="0"/>
              <a:t>is implemented for the designed LLIN</a:t>
            </a:r>
          </a:p>
        </p:txBody>
      </p:sp>
      <p:pic>
        <p:nvPicPr>
          <p:cNvPr id="50" name="Graphic 49" descr="Recycle with solid fill">
            <a:extLst>
              <a:ext uri="{FF2B5EF4-FFF2-40B4-BE49-F238E27FC236}">
                <a16:creationId xmlns:a16="http://schemas.microsoft.com/office/drawing/2014/main" id="{CD8FBD48-E8AA-13D3-ABD7-4A7EB32EECB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4831345" y="3524287"/>
            <a:ext cx="822121" cy="822121"/>
          </a:xfrm>
          <a:prstGeom prst="rect">
            <a:avLst/>
          </a:prstGeom>
        </p:spPr>
      </p:pic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6CE803A1-0C8E-3107-6155-F170069A3B70}"/>
              </a:ext>
            </a:extLst>
          </p:cNvPr>
          <p:cNvCxnSpPr/>
          <p:nvPr/>
        </p:nvCxnSpPr>
        <p:spPr>
          <a:xfrm>
            <a:off x="5407065" y="1702690"/>
            <a:ext cx="221604" cy="268448"/>
          </a:xfrm>
          <a:prstGeom prst="straightConnector1">
            <a:avLst/>
          </a:prstGeom>
          <a:ln w="38100"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912401B2-14ED-2117-F530-E4AF4854E7BD}"/>
              </a:ext>
            </a:extLst>
          </p:cNvPr>
          <p:cNvCxnSpPr>
            <a:cxnSpLocks/>
          </p:cNvCxnSpPr>
          <p:nvPr/>
        </p:nvCxnSpPr>
        <p:spPr>
          <a:xfrm flipH="1">
            <a:off x="6573786" y="1696671"/>
            <a:ext cx="221604" cy="268448"/>
          </a:xfrm>
          <a:prstGeom prst="straightConnector1">
            <a:avLst/>
          </a:prstGeom>
          <a:ln w="38100"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1" name="Group 80">
            <a:extLst>
              <a:ext uri="{FF2B5EF4-FFF2-40B4-BE49-F238E27FC236}">
                <a16:creationId xmlns:a16="http://schemas.microsoft.com/office/drawing/2014/main" id="{E1DE20DF-0A30-7864-ED8A-F11C61A9D581}"/>
              </a:ext>
            </a:extLst>
          </p:cNvPr>
          <p:cNvGrpSpPr/>
          <p:nvPr/>
        </p:nvGrpSpPr>
        <p:grpSpPr>
          <a:xfrm>
            <a:off x="4601917" y="721450"/>
            <a:ext cx="1265711" cy="822121"/>
            <a:chOff x="4356010" y="721453"/>
            <a:chExt cx="1265711" cy="822121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F26F9BA9-4176-6037-A040-D05BC5A4546B}"/>
                </a:ext>
              </a:extLst>
            </p:cNvPr>
            <p:cNvGrpSpPr/>
            <p:nvPr/>
          </p:nvGrpSpPr>
          <p:grpSpPr>
            <a:xfrm flipH="1">
              <a:off x="4356010" y="721453"/>
              <a:ext cx="1100268" cy="822121"/>
              <a:chOff x="5118009" y="906010"/>
              <a:chExt cx="1100268" cy="822121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0357678E-5F1D-CA6C-6162-BC9C54E45AC4}"/>
                  </a:ext>
                </a:extLst>
              </p:cNvPr>
              <p:cNvSpPr/>
              <p:nvPr/>
            </p:nvSpPr>
            <p:spPr>
              <a:xfrm>
                <a:off x="5318618" y="1023457"/>
                <a:ext cx="318781" cy="70467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" name="Isosceles Triangle 11">
                <a:extLst>
                  <a:ext uri="{FF2B5EF4-FFF2-40B4-BE49-F238E27FC236}">
                    <a16:creationId xmlns:a16="http://schemas.microsoft.com/office/drawing/2014/main" id="{3268DAB8-E147-9913-41A8-D8E03E706C4D}"/>
                  </a:ext>
                </a:extLst>
              </p:cNvPr>
              <p:cNvSpPr/>
              <p:nvPr/>
            </p:nvSpPr>
            <p:spPr>
              <a:xfrm>
                <a:off x="5118009" y="1258347"/>
                <a:ext cx="720000" cy="46978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Isosceles Triangle 12">
                <a:extLst>
                  <a:ext uri="{FF2B5EF4-FFF2-40B4-BE49-F238E27FC236}">
                    <a16:creationId xmlns:a16="http://schemas.microsoft.com/office/drawing/2014/main" id="{C9C9E46B-F0CD-525C-47F6-DB67D8CE3255}"/>
                  </a:ext>
                </a:extLst>
              </p:cNvPr>
              <p:cNvSpPr/>
              <p:nvPr/>
            </p:nvSpPr>
            <p:spPr>
              <a:xfrm flipV="1">
                <a:off x="5118009" y="906010"/>
                <a:ext cx="720000" cy="46978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Freeform: Shape 13">
                <a:extLst>
                  <a:ext uri="{FF2B5EF4-FFF2-40B4-BE49-F238E27FC236}">
                    <a16:creationId xmlns:a16="http://schemas.microsoft.com/office/drawing/2014/main" id="{C89FC11C-48C4-71B6-F14D-3346AF28FEB8}"/>
                  </a:ext>
                </a:extLst>
              </p:cNvPr>
              <p:cNvSpPr/>
              <p:nvPr/>
            </p:nvSpPr>
            <p:spPr>
              <a:xfrm>
                <a:off x="5637400" y="955424"/>
                <a:ext cx="580877" cy="471620"/>
              </a:xfrm>
              <a:custGeom>
                <a:avLst/>
                <a:gdLst>
                  <a:gd name="connsiteX0" fmla="*/ 0 w 749387"/>
                  <a:gd name="connsiteY0" fmla="*/ 279884 h 471620"/>
                  <a:gd name="connsiteX1" fmla="*/ 738231 w 749387"/>
                  <a:gd name="connsiteY1" fmla="*/ 3047 h 471620"/>
                  <a:gd name="connsiteX2" fmla="*/ 453005 w 749387"/>
                  <a:gd name="connsiteY2" fmla="*/ 439274 h 471620"/>
                  <a:gd name="connsiteX3" fmla="*/ 562062 w 749387"/>
                  <a:gd name="connsiteY3" fmla="*/ 405718 h 4716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49387" h="471620">
                    <a:moveTo>
                      <a:pt x="0" y="279884"/>
                    </a:moveTo>
                    <a:cubicBezTo>
                      <a:pt x="331365" y="128183"/>
                      <a:pt x="662730" y="-23518"/>
                      <a:pt x="738231" y="3047"/>
                    </a:cubicBezTo>
                    <a:cubicBezTo>
                      <a:pt x="813732" y="29612"/>
                      <a:pt x="482366" y="372162"/>
                      <a:pt x="453005" y="439274"/>
                    </a:cubicBezTo>
                    <a:cubicBezTo>
                      <a:pt x="423644" y="506386"/>
                      <a:pt x="492853" y="456052"/>
                      <a:pt x="562062" y="405718"/>
                    </a:cubicBezTo>
                  </a:path>
                </a:pathLst>
              </a:cu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59" name="Arc 58">
              <a:extLst>
                <a:ext uri="{FF2B5EF4-FFF2-40B4-BE49-F238E27FC236}">
                  <a16:creationId xmlns:a16="http://schemas.microsoft.com/office/drawing/2014/main" id="{22EFD95C-00BC-CF04-58BA-A782D3119295}"/>
                </a:ext>
              </a:extLst>
            </p:cNvPr>
            <p:cNvSpPr/>
            <p:nvPr/>
          </p:nvSpPr>
          <p:spPr>
            <a:xfrm rot="16200000" flipH="1">
              <a:off x="5108721" y="617529"/>
              <a:ext cx="324000" cy="702000"/>
            </a:xfrm>
            <a:prstGeom prst="arc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4" name="Arc 63">
              <a:extLst>
                <a:ext uri="{FF2B5EF4-FFF2-40B4-BE49-F238E27FC236}">
                  <a16:creationId xmlns:a16="http://schemas.microsoft.com/office/drawing/2014/main" id="{79DA9685-56C6-2FD5-67C5-C9C3EE436D06}"/>
                </a:ext>
              </a:extLst>
            </p:cNvPr>
            <p:cNvSpPr/>
            <p:nvPr/>
          </p:nvSpPr>
          <p:spPr>
            <a:xfrm rot="16200000" flipH="1">
              <a:off x="5108721" y="702169"/>
              <a:ext cx="324000" cy="702000"/>
            </a:xfrm>
            <a:prstGeom prst="arc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" name="Arc 64">
              <a:extLst>
                <a:ext uri="{FF2B5EF4-FFF2-40B4-BE49-F238E27FC236}">
                  <a16:creationId xmlns:a16="http://schemas.microsoft.com/office/drawing/2014/main" id="{2D0DF5D9-A018-BF96-E596-05C3D6F2F500}"/>
                </a:ext>
              </a:extLst>
            </p:cNvPr>
            <p:cNvSpPr/>
            <p:nvPr/>
          </p:nvSpPr>
          <p:spPr>
            <a:xfrm rot="16200000" flipH="1">
              <a:off x="5097954" y="787991"/>
              <a:ext cx="324000" cy="702000"/>
            </a:xfrm>
            <a:prstGeom prst="arc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6" name="Arc 65">
              <a:extLst>
                <a:ext uri="{FF2B5EF4-FFF2-40B4-BE49-F238E27FC236}">
                  <a16:creationId xmlns:a16="http://schemas.microsoft.com/office/drawing/2014/main" id="{C378F388-E58B-DBEF-3A76-32CA50CDE652}"/>
                </a:ext>
              </a:extLst>
            </p:cNvPr>
            <p:cNvSpPr/>
            <p:nvPr/>
          </p:nvSpPr>
          <p:spPr>
            <a:xfrm rot="5400000">
              <a:off x="4743329" y="643001"/>
              <a:ext cx="324000" cy="702000"/>
            </a:xfrm>
            <a:prstGeom prst="arc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Arc 66">
              <a:extLst>
                <a:ext uri="{FF2B5EF4-FFF2-40B4-BE49-F238E27FC236}">
                  <a16:creationId xmlns:a16="http://schemas.microsoft.com/office/drawing/2014/main" id="{98B38350-8290-C034-2058-1898B9BA126B}"/>
                </a:ext>
              </a:extLst>
            </p:cNvPr>
            <p:cNvSpPr/>
            <p:nvPr/>
          </p:nvSpPr>
          <p:spPr>
            <a:xfrm rot="5400000">
              <a:off x="4743329" y="727641"/>
              <a:ext cx="324000" cy="702000"/>
            </a:xfrm>
            <a:prstGeom prst="arc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Arc 67">
              <a:extLst>
                <a:ext uri="{FF2B5EF4-FFF2-40B4-BE49-F238E27FC236}">
                  <a16:creationId xmlns:a16="http://schemas.microsoft.com/office/drawing/2014/main" id="{06898F08-40B2-3CA6-56CD-E5F946595F3B}"/>
                </a:ext>
              </a:extLst>
            </p:cNvPr>
            <p:cNvSpPr/>
            <p:nvPr/>
          </p:nvSpPr>
          <p:spPr>
            <a:xfrm rot="5400000">
              <a:off x="4732562" y="813463"/>
              <a:ext cx="324000" cy="702000"/>
            </a:xfrm>
            <a:prstGeom prst="arc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B8A0A173-8B36-7A42-2670-B9E45D9A1F5B}"/>
              </a:ext>
            </a:extLst>
          </p:cNvPr>
          <p:cNvGrpSpPr/>
          <p:nvPr/>
        </p:nvGrpSpPr>
        <p:grpSpPr>
          <a:xfrm>
            <a:off x="6325414" y="721450"/>
            <a:ext cx="1265711" cy="822121"/>
            <a:chOff x="6179287" y="721450"/>
            <a:chExt cx="1265711" cy="822121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1CD4A6E0-F119-C436-94BC-7C6CED69A0E5}"/>
                </a:ext>
              </a:extLst>
            </p:cNvPr>
            <p:cNvGrpSpPr/>
            <p:nvPr/>
          </p:nvGrpSpPr>
          <p:grpSpPr>
            <a:xfrm>
              <a:off x="6344730" y="721450"/>
              <a:ext cx="1100268" cy="822121"/>
              <a:chOff x="5118009" y="906010"/>
              <a:chExt cx="1100268" cy="822121"/>
            </a:xfrm>
          </p:grpSpPr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A421D438-7137-66FA-8F14-91527C887C56}"/>
                  </a:ext>
                </a:extLst>
              </p:cNvPr>
              <p:cNvSpPr/>
              <p:nvPr/>
            </p:nvSpPr>
            <p:spPr>
              <a:xfrm>
                <a:off x="5318618" y="1023457"/>
                <a:ext cx="318781" cy="70467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1" name="Isosceles Triangle 70">
                <a:extLst>
                  <a:ext uri="{FF2B5EF4-FFF2-40B4-BE49-F238E27FC236}">
                    <a16:creationId xmlns:a16="http://schemas.microsoft.com/office/drawing/2014/main" id="{9D0F200A-C267-4635-339D-F3CA3A4B2E4E}"/>
                  </a:ext>
                </a:extLst>
              </p:cNvPr>
              <p:cNvSpPr/>
              <p:nvPr/>
            </p:nvSpPr>
            <p:spPr>
              <a:xfrm>
                <a:off x="5118009" y="1258347"/>
                <a:ext cx="720000" cy="46978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2" name="Isosceles Triangle 71">
                <a:extLst>
                  <a:ext uri="{FF2B5EF4-FFF2-40B4-BE49-F238E27FC236}">
                    <a16:creationId xmlns:a16="http://schemas.microsoft.com/office/drawing/2014/main" id="{18A781FA-A33B-E89E-E020-254D1D166F92}"/>
                  </a:ext>
                </a:extLst>
              </p:cNvPr>
              <p:cNvSpPr/>
              <p:nvPr/>
            </p:nvSpPr>
            <p:spPr>
              <a:xfrm flipV="1">
                <a:off x="5118009" y="906010"/>
                <a:ext cx="720000" cy="46978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3" name="Freeform: Shape 72">
                <a:extLst>
                  <a:ext uri="{FF2B5EF4-FFF2-40B4-BE49-F238E27FC236}">
                    <a16:creationId xmlns:a16="http://schemas.microsoft.com/office/drawing/2014/main" id="{5536023D-832E-DBA2-440A-3758023924C8}"/>
                  </a:ext>
                </a:extLst>
              </p:cNvPr>
              <p:cNvSpPr/>
              <p:nvPr/>
            </p:nvSpPr>
            <p:spPr>
              <a:xfrm>
                <a:off x="5637400" y="955424"/>
                <a:ext cx="580877" cy="471620"/>
              </a:xfrm>
              <a:custGeom>
                <a:avLst/>
                <a:gdLst>
                  <a:gd name="connsiteX0" fmla="*/ 0 w 749387"/>
                  <a:gd name="connsiteY0" fmla="*/ 279884 h 471620"/>
                  <a:gd name="connsiteX1" fmla="*/ 738231 w 749387"/>
                  <a:gd name="connsiteY1" fmla="*/ 3047 h 471620"/>
                  <a:gd name="connsiteX2" fmla="*/ 453005 w 749387"/>
                  <a:gd name="connsiteY2" fmla="*/ 439274 h 471620"/>
                  <a:gd name="connsiteX3" fmla="*/ 562062 w 749387"/>
                  <a:gd name="connsiteY3" fmla="*/ 405718 h 4716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49387" h="471620">
                    <a:moveTo>
                      <a:pt x="0" y="279884"/>
                    </a:moveTo>
                    <a:cubicBezTo>
                      <a:pt x="331365" y="128183"/>
                      <a:pt x="662730" y="-23518"/>
                      <a:pt x="738231" y="3047"/>
                    </a:cubicBezTo>
                    <a:cubicBezTo>
                      <a:pt x="813732" y="29612"/>
                      <a:pt x="482366" y="372162"/>
                      <a:pt x="453005" y="439274"/>
                    </a:cubicBezTo>
                    <a:cubicBezTo>
                      <a:pt x="423644" y="506386"/>
                      <a:pt x="492853" y="456052"/>
                      <a:pt x="562062" y="405718"/>
                    </a:cubicBezTo>
                  </a:path>
                </a:pathLst>
              </a:custGeom>
              <a:noFill/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74" name="Arc 73">
              <a:extLst>
                <a:ext uri="{FF2B5EF4-FFF2-40B4-BE49-F238E27FC236}">
                  <a16:creationId xmlns:a16="http://schemas.microsoft.com/office/drawing/2014/main" id="{A0F82B91-C708-AA67-C212-76192490F3BE}"/>
                </a:ext>
              </a:extLst>
            </p:cNvPr>
            <p:cNvSpPr/>
            <p:nvPr/>
          </p:nvSpPr>
          <p:spPr>
            <a:xfrm rot="5400000">
              <a:off x="6368287" y="617526"/>
              <a:ext cx="324000" cy="702000"/>
            </a:xfrm>
            <a:prstGeom prst="arc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Arc 74">
              <a:extLst>
                <a:ext uri="{FF2B5EF4-FFF2-40B4-BE49-F238E27FC236}">
                  <a16:creationId xmlns:a16="http://schemas.microsoft.com/office/drawing/2014/main" id="{20A1A900-DE47-9DC6-103D-B082F381455B}"/>
                </a:ext>
              </a:extLst>
            </p:cNvPr>
            <p:cNvSpPr/>
            <p:nvPr/>
          </p:nvSpPr>
          <p:spPr>
            <a:xfrm rot="5400000">
              <a:off x="6368287" y="702166"/>
              <a:ext cx="324000" cy="702000"/>
            </a:xfrm>
            <a:prstGeom prst="arc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Arc 75">
              <a:extLst>
                <a:ext uri="{FF2B5EF4-FFF2-40B4-BE49-F238E27FC236}">
                  <a16:creationId xmlns:a16="http://schemas.microsoft.com/office/drawing/2014/main" id="{058D0CF2-8A2D-269A-032C-A027D75B6C34}"/>
                </a:ext>
              </a:extLst>
            </p:cNvPr>
            <p:cNvSpPr/>
            <p:nvPr/>
          </p:nvSpPr>
          <p:spPr>
            <a:xfrm rot="5400000">
              <a:off x="6379054" y="787988"/>
              <a:ext cx="324000" cy="702000"/>
            </a:xfrm>
            <a:prstGeom prst="arc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Arc 76">
              <a:extLst>
                <a:ext uri="{FF2B5EF4-FFF2-40B4-BE49-F238E27FC236}">
                  <a16:creationId xmlns:a16="http://schemas.microsoft.com/office/drawing/2014/main" id="{4DADCCB3-CB86-7B89-CBF6-391AE6B08AF0}"/>
                </a:ext>
              </a:extLst>
            </p:cNvPr>
            <p:cNvSpPr/>
            <p:nvPr/>
          </p:nvSpPr>
          <p:spPr>
            <a:xfrm rot="16200000" flipH="1">
              <a:off x="6733679" y="642998"/>
              <a:ext cx="324000" cy="702000"/>
            </a:xfrm>
            <a:prstGeom prst="arc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8" name="Arc 77">
              <a:extLst>
                <a:ext uri="{FF2B5EF4-FFF2-40B4-BE49-F238E27FC236}">
                  <a16:creationId xmlns:a16="http://schemas.microsoft.com/office/drawing/2014/main" id="{13D232FC-1E5E-180B-80CC-8E6EBED704F4}"/>
                </a:ext>
              </a:extLst>
            </p:cNvPr>
            <p:cNvSpPr/>
            <p:nvPr/>
          </p:nvSpPr>
          <p:spPr>
            <a:xfrm rot="16200000" flipH="1">
              <a:off x="6733679" y="727638"/>
              <a:ext cx="324000" cy="702000"/>
            </a:xfrm>
            <a:prstGeom prst="arc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9" name="Arc 78">
              <a:extLst>
                <a:ext uri="{FF2B5EF4-FFF2-40B4-BE49-F238E27FC236}">
                  <a16:creationId xmlns:a16="http://schemas.microsoft.com/office/drawing/2014/main" id="{43282F8A-0648-29F2-5524-A63B8148A9F2}"/>
                </a:ext>
              </a:extLst>
            </p:cNvPr>
            <p:cNvSpPr/>
            <p:nvPr/>
          </p:nvSpPr>
          <p:spPr>
            <a:xfrm rot="16200000" flipH="1">
              <a:off x="6744446" y="813460"/>
              <a:ext cx="324000" cy="702000"/>
            </a:xfrm>
            <a:prstGeom prst="arc">
              <a:avLst/>
            </a:prstGeom>
            <a:ln w="127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FE6C0688-E1D7-DF46-534B-D6CD5E88BC04}"/>
              </a:ext>
            </a:extLst>
          </p:cNvPr>
          <p:cNvCxnSpPr>
            <a:cxnSpLocks/>
          </p:cNvCxnSpPr>
          <p:nvPr/>
        </p:nvCxnSpPr>
        <p:spPr>
          <a:xfrm flipH="1">
            <a:off x="5407065" y="3161260"/>
            <a:ext cx="221604" cy="268448"/>
          </a:xfrm>
          <a:prstGeom prst="straightConnector1">
            <a:avLst/>
          </a:prstGeom>
          <a:ln w="38100"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0DE78C7D-07DF-64E3-8E86-1CDB9369BFBC}"/>
              </a:ext>
            </a:extLst>
          </p:cNvPr>
          <p:cNvCxnSpPr>
            <a:cxnSpLocks/>
          </p:cNvCxnSpPr>
          <p:nvPr/>
        </p:nvCxnSpPr>
        <p:spPr>
          <a:xfrm>
            <a:off x="6573786" y="3155241"/>
            <a:ext cx="221604" cy="268448"/>
          </a:xfrm>
          <a:prstGeom prst="straightConnector1">
            <a:avLst/>
          </a:prstGeom>
          <a:ln w="38100"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DB6B037D-2787-3729-4B96-16BBC0E71708}"/>
              </a:ext>
            </a:extLst>
          </p:cNvPr>
          <p:cNvCxnSpPr/>
          <p:nvPr/>
        </p:nvCxnSpPr>
        <p:spPr>
          <a:xfrm>
            <a:off x="5424050" y="4560962"/>
            <a:ext cx="221604" cy="268448"/>
          </a:xfrm>
          <a:prstGeom prst="straightConnector1">
            <a:avLst/>
          </a:prstGeom>
          <a:ln w="38100"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94556B5E-DE8B-667F-B36F-0BBD31FF42A1}"/>
              </a:ext>
            </a:extLst>
          </p:cNvPr>
          <p:cNvCxnSpPr>
            <a:cxnSpLocks/>
          </p:cNvCxnSpPr>
          <p:nvPr/>
        </p:nvCxnSpPr>
        <p:spPr>
          <a:xfrm flipH="1">
            <a:off x="6590771" y="4554943"/>
            <a:ext cx="221604" cy="268448"/>
          </a:xfrm>
          <a:prstGeom prst="straightConnector1">
            <a:avLst/>
          </a:prstGeom>
          <a:ln w="38100">
            <a:solidFill>
              <a:schemeClr val="bg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76074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6EF3636D6506E458CE89FCEF7755966" ma:contentTypeVersion="16" ma:contentTypeDescription="Create a new document." ma:contentTypeScope="" ma:versionID="0cbe7378c2e4eaba79e9fc2e0705ec1f">
  <xsd:schema xmlns:xsd="http://www.w3.org/2001/XMLSchema" xmlns:xs="http://www.w3.org/2001/XMLSchema" xmlns:p="http://schemas.microsoft.com/office/2006/metadata/properties" xmlns:ns2="79d455e9-da80-41bf-a423-2d47ac6615e2" xmlns:ns3="4ae321f9-10f2-4547-9d38-037ad2df187c" targetNamespace="http://schemas.microsoft.com/office/2006/metadata/properties" ma:root="true" ma:fieldsID="896679ba399f16fb01d4cd8ef2b05b31" ns2:_="" ns3:_="">
    <xsd:import namespace="79d455e9-da80-41bf-a423-2d47ac6615e2"/>
    <xsd:import namespace="4ae321f9-10f2-4547-9d38-037ad2df187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Location" minOccurs="0"/>
                <xsd:element ref="ns2:MediaServiceObjectDetectorVersion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9d455e9-da80-41bf-a423-2d47ac6615e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a62b72aa-f2ad-421f-b636-7f0f87e2f2b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0" nillable="true" ma:displayName="MediaServiceDateTaken" ma:internalName="MediaServiceDateTaken" ma:readOnly="true">
      <xsd:simpleType>
        <xsd:restriction base="dms:Text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e321f9-10f2-4547-9d38-037ad2df187c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2174773d-892a-4f30-a565-4aa6784a5d3b}" ma:internalName="TaxCatchAll" ma:showField="CatchAllData" ma:web="4ae321f9-10f2-4547-9d38-037ad2df187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79d455e9-da80-41bf-a423-2d47ac6615e2">
      <Terms xmlns="http://schemas.microsoft.com/office/infopath/2007/PartnerControls"/>
    </lcf76f155ced4ddcb4097134ff3c332f>
    <TaxCatchAll xmlns="4ae321f9-10f2-4547-9d38-037ad2df187c" xsi:nil="true"/>
  </documentManagement>
</p:properties>
</file>

<file path=customXml/itemProps1.xml><?xml version="1.0" encoding="utf-8"?>
<ds:datastoreItem xmlns:ds="http://schemas.openxmlformats.org/officeDocument/2006/customXml" ds:itemID="{D1FC5F3A-95C3-4174-AE77-63F9BBA42CAF}"/>
</file>

<file path=customXml/itemProps2.xml><?xml version="1.0" encoding="utf-8"?>
<ds:datastoreItem xmlns:ds="http://schemas.openxmlformats.org/officeDocument/2006/customXml" ds:itemID="{B16C3705-458D-4E4B-920C-72C4D048326A}"/>
</file>

<file path=customXml/itemProps3.xml><?xml version="1.0" encoding="utf-8"?>
<ds:datastoreItem xmlns:ds="http://schemas.openxmlformats.org/officeDocument/2006/customXml" ds:itemID="{3A4F34DF-EA6C-4D53-88E0-838DDD60995D}"/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103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gwick Phil GBJH</dc:creator>
  <cp:lastModifiedBy>Madgwick Phil GBJH</cp:lastModifiedBy>
  <cp:revision>2</cp:revision>
  <dcterms:created xsi:type="dcterms:W3CDTF">2023-06-05T15:16:44Z</dcterms:created>
  <dcterms:modified xsi:type="dcterms:W3CDTF">2023-06-09T15:34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6EF3636D6506E458CE89FCEF7755966</vt:lpwstr>
  </property>
</Properties>
</file>